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759450" cy="774065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76B576-14DC-427B-B684-1D31ACA85BF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88720" y="309240"/>
            <a:ext cx="5182920" cy="129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88720" y="1804680"/>
            <a:ext cx="5182920" cy="243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88720" y="4473720"/>
            <a:ext cx="5182920" cy="243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BC4A2F-8601-4ADC-A2C9-0133638AF3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88720" y="309240"/>
            <a:ext cx="5182920" cy="129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88720" y="1804680"/>
            <a:ext cx="2529000" cy="243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944440" y="1804680"/>
            <a:ext cx="2529000" cy="243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88720" y="4473720"/>
            <a:ext cx="2529000" cy="243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944440" y="4473720"/>
            <a:ext cx="2529000" cy="243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63609C-5ED3-4BAD-895A-FBBB246F2BB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88720" y="309240"/>
            <a:ext cx="5182920" cy="129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88720" y="1804680"/>
            <a:ext cx="1668600" cy="243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041200" y="1804680"/>
            <a:ext cx="1668600" cy="243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793680" y="1804680"/>
            <a:ext cx="1668600" cy="243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88720" y="4473720"/>
            <a:ext cx="1668600" cy="243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041200" y="4473720"/>
            <a:ext cx="1668600" cy="243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793680" y="4473720"/>
            <a:ext cx="1668600" cy="243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617D12-F3D0-4C30-BB47-31921DD9670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88720" y="309240"/>
            <a:ext cx="5182920" cy="129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88720" y="1804680"/>
            <a:ext cx="5182920" cy="51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BB30BB-6CCF-4B00-A2DF-CF016559A6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88720" y="309240"/>
            <a:ext cx="5182920" cy="129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88720" y="1804680"/>
            <a:ext cx="5182920" cy="511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73A154-9C80-4B84-9180-0BB18B6291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88720" y="309240"/>
            <a:ext cx="5182920" cy="129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88720" y="1804680"/>
            <a:ext cx="2529000" cy="511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944440" y="1804680"/>
            <a:ext cx="2529000" cy="511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41266D-20A9-45E2-A4CC-3E7E77DC4D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88720" y="309240"/>
            <a:ext cx="5182920" cy="129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7141D4-FEDF-4EC3-842B-DD42AD1CC6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88720" y="309240"/>
            <a:ext cx="5182920" cy="5983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8FB55B-9B5A-4B35-82B7-C217AB7AD3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88720" y="309240"/>
            <a:ext cx="5182920" cy="129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88720" y="1804680"/>
            <a:ext cx="2529000" cy="243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944440" y="1804680"/>
            <a:ext cx="2529000" cy="511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88720" y="4473720"/>
            <a:ext cx="2529000" cy="243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B0048B-5623-43C4-A585-F2394FDDEC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88720" y="309240"/>
            <a:ext cx="5182920" cy="129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88720" y="1804680"/>
            <a:ext cx="2529000" cy="511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944440" y="1804680"/>
            <a:ext cx="2529000" cy="243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944440" y="4473720"/>
            <a:ext cx="2529000" cy="243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A3C700-6E69-4860-BB60-AC806B8AE0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88720" y="309240"/>
            <a:ext cx="5182920" cy="129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88720" y="1804680"/>
            <a:ext cx="2529000" cy="243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944440" y="1804680"/>
            <a:ext cx="2529000" cy="243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88720" y="4473720"/>
            <a:ext cx="5182920" cy="243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FC772C-C087-48E4-B65A-9D981A28A0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88720" y="309240"/>
            <a:ext cx="5182920" cy="129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88720" y="1804680"/>
            <a:ext cx="5182920" cy="511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2000"/>
          </a:bodyPr>
          <a:p>
            <a:pPr marL="315360" indent="-31536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683280" indent="-2628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051560" indent="-21024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472040" indent="-2102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1892520" indent="-21024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1892520" indent="-21024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1892520" indent="-21024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88720" y="7048080"/>
            <a:ext cx="1344600" cy="53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968120" y="7048080"/>
            <a:ext cx="1824120" cy="53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127040" y="7048080"/>
            <a:ext cx="1344600" cy="53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808C2D2-6164-4CCA-9164-E79E7196B25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800" y="104760"/>
            <a:ext cx="5510520" cy="7455240"/>
            <a:chOff x="1800" y="104760"/>
            <a:chExt cx="5510520" cy="7455240"/>
          </a:xfrm>
        </p:grpSpPr>
        <p:grpSp>
          <p:nvGrpSpPr>
            <p:cNvPr id="42" name=""/>
            <p:cNvGrpSpPr/>
            <p:nvPr/>
          </p:nvGrpSpPr>
          <p:grpSpPr>
            <a:xfrm>
              <a:off x="1800" y="2620800"/>
              <a:ext cx="5435280" cy="1910160"/>
              <a:chOff x="1800" y="2620800"/>
              <a:chExt cx="5435280" cy="1910160"/>
            </a:xfrm>
          </p:grpSpPr>
          <p:sp>
            <p:nvSpPr>
              <p:cNvPr id="43" name=""/>
              <p:cNvSpPr/>
              <p:nvPr/>
            </p:nvSpPr>
            <p:spPr>
              <a:xfrm>
                <a:off x="1800" y="2620800"/>
                <a:ext cx="345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4" name=""/>
              <p:cNvGrpSpPr/>
              <p:nvPr/>
            </p:nvGrpSpPr>
            <p:grpSpPr>
              <a:xfrm>
                <a:off x="944640" y="2728800"/>
                <a:ext cx="4492440" cy="1802160"/>
                <a:chOff x="944640" y="2728800"/>
                <a:chExt cx="4492440" cy="1802160"/>
              </a:xfrm>
            </p:grpSpPr>
            <p:sp>
              <p:nvSpPr>
                <p:cNvPr id="45" name=""/>
                <p:cNvSpPr/>
                <p:nvPr/>
              </p:nvSpPr>
              <p:spPr>
                <a:xfrm>
                  <a:off x="4561560" y="2728800"/>
                  <a:ext cx="64692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fr-FR" sz="1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i="1" lang="fr-FR" sz="1200" spc="-1" strike="noStrike">
                      <a:solidFill>
                        <a:srgbClr val="000000"/>
                      </a:solidFill>
                      <a:latin typeface="Arial"/>
                    </a:rPr>
                    <a:t>A.viridis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" name=""/>
                <p:cNvSpPr/>
                <p:nvPr/>
              </p:nvSpPr>
              <p:spPr>
                <a:xfrm>
                  <a:off x="3824280" y="2844720"/>
                  <a:ext cx="719280" cy="125280"/>
                </a:xfrm>
                <a:custGeom>
                  <a:avLst/>
                  <a:gdLst/>
                  <a:ahLst/>
                  <a:rect l="l" t="t" r="r" b="b"/>
                  <a:pathLst>
                    <a:path w="453" h="79">
                      <a:moveTo>
                        <a:pt x="0" y="79"/>
                      </a:moveTo>
                      <a:lnTo>
                        <a:pt x="0" y="0"/>
                      </a:lnTo>
                      <a:lnTo>
                        <a:pt x="453" y="0"/>
                      </a:lnTo>
                    </a:path>
                  </a:pathLst>
                </a:custGeom>
                <a:noFill/>
                <a:ln w="270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" name=""/>
                <p:cNvSpPr/>
                <p:nvPr/>
              </p:nvSpPr>
              <p:spPr>
                <a:xfrm>
                  <a:off x="4561560" y="2998800"/>
                  <a:ext cx="87552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fr-FR" sz="1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i="1" lang="fr-FR" sz="1200" spc="-1" strike="noStrike">
                      <a:solidFill>
                        <a:srgbClr val="000000"/>
                      </a:solidFill>
                      <a:latin typeface="Arial"/>
                    </a:rPr>
                    <a:t>A.millepora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" name=""/>
                <p:cNvSpPr/>
                <p:nvPr/>
              </p:nvSpPr>
              <p:spPr>
                <a:xfrm>
                  <a:off x="3824280" y="2997000"/>
                  <a:ext cx="719280" cy="117360"/>
                </a:xfrm>
                <a:custGeom>
                  <a:avLst/>
                  <a:gdLst/>
                  <a:ahLst/>
                  <a:rect l="l" t="t" r="r" b="b"/>
                  <a:pathLst>
                    <a:path w="453" h="74">
                      <a:moveTo>
                        <a:pt x="0" y="0"/>
                      </a:moveTo>
                      <a:lnTo>
                        <a:pt x="0" y="74"/>
                      </a:lnTo>
                      <a:lnTo>
                        <a:pt x="453" y="74"/>
                      </a:lnTo>
                    </a:path>
                  </a:pathLst>
                </a:custGeom>
                <a:noFill/>
                <a:ln w="270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" name=""/>
                <p:cNvSpPr/>
                <p:nvPr/>
              </p:nvSpPr>
              <p:spPr>
                <a:xfrm>
                  <a:off x="3103560" y="2979720"/>
                  <a:ext cx="720720" cy="260280"/>
                </a:xfrm>
                <a:custGeom>
                  <a:avLst/>
                  <a:gdLst/>
                  <a:ahLst/>
                  <a:rect l="l" t="t" r="r" b="b"/>
                  <a:pathLst>
                    <a:path w="454" h="164">
                      <a:moveTo>
                        <a:pt x="0" y="164"/>
                      </a:moveTo>
                      <a:lnTo>
                        <a:pt x="0" y="0"/>
                      </a:lnTo>
                      <a:lnTo>
                        <a:pt x="454" y="0"/>
                      </a:lnTo>
                    </a:path>
                  </a:pathLst>
                </a:custGeom>
                <a:noFill/>
                <a:ln w="270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" name=""/>
                <p:cNvSpPr/>
                <p:nvPr/>
              </p:nvSpPr>
              <p:spPr>
                <a:xfrm>
                  <a:off x="4561200" y="3268440"/>
                  <a:ext cx="8330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fr-FR" sz="1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i="1" lang="fr-FR" sz="1200" spc="-1" strike="noStrike">
                      <a:solidFill>
                        <a:srgbClr val="000000"/>
                      </a:solidFill>
                      <a:latin typeface="Arial"/>
                    </a:rPr>
                    <a:t>C.briggsae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" name=""/>
                <p:cNvSpPr/>
                <p:nvPr/>
              </p:nvSpPr>
              <p:spPr>
                <a:xfrm>
                  <a:off x="3824280" y="3384360"/>
                  <a:ext cx="719280" cy="125280"/>
                </a:xfrm>
                <a:custGeom>
                  <a:avLst/>
                  <a:gdLst/>
                  <a:ahLst/>
                  <a:rect l="l" t="t" r="r" b="b"/>
                  <a:pathLst>
                    <a:path w="453" h="79">
                      <a:moveTo>
                        <a:pt x="0" y="79"/>
                      </a:moveTo>
                      <a:lnTo>
                        <a:pt x="0" y="0"/>
                      </a:lnTo>
                      <a:lnTo>
                        <a:pt x="453" y="0"/>
                      </a:lnTo>
                    </a:path>
                  </a:pathLst>
                </a:custGeom>
                <a:noFill/>
                <a:ln w="270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" name=""/>
                <p:cNvSpPr/>
                <p:nvPr/>
              </p:nvSpPr>
              <p:spPr>
                <a:xfrm>
                  <a:off x="4560480" y="3538440"/>
                  <a:ext cx="7660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fr-FR" sz="1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i="1" lang="fr-FR" sz="1200" spc="-1" strike="noStrike">
                      <a:solidFill>
                        <a:srgbClr val="000000"/>
                      </a:solidFill>
                      <a:latin typeface="Arial"/>
                    </a:rPr>
                    <a:t>C.elegans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"/>
                <p:cNvSpPr/>
                <p:nvPr/>
              </p:nvSpPr>
              <p:spPr>
                <a:xfrm>
                  <a:off x="3824280" y="3536640"/>
                  <a:ext cx="719280" cy="117720"/>
                </a:xfrm>
                <a:custGeom>
                  <a:avLst/>
                  <a:gdLst/>
                  <a:ahLst/>
                  <a:rect l="l" t="t" r="r" b="b"/>
                  <a:pathLst>
                    <a:path w="453" h="74">
                      <a:moveTo>
                        <a:pt x="0" y="0"/>
                      </a:moveTo>
                      <a:lnTo>
                        <a:pt x="0" y="74"/>
                      </a:lnTo>
                      <a:lnTo>
                        <a:pt x="453" y="74"/>
                      </a:lnTo>
                    </a:path>
                  </a:pathLst>
                </a:custGeom>
                <a:noFill/>
                <a:ln w="270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"/>
                <p:cNvSpPr/>
                <p:nvPr/>
              </p:nvSpPr>
              <p:spPr>
                <a:xfrm>
                  <a:off x="3103560" y="3267000"/>
                  <a:ext cx="720720" cy="252360"/>
                </a:xfrm>
                <a:custGeom>
                  <a:avLst/>
                  <a:gdLst/>
                  <a:ahLst/>
                  <a:rect l="l" t="t" r="r" b="b"/>
                  <a:pathLst>
                    <a:path w="454" h="159">
                      <a:moveTo>
                        <a:pt x="0" y="0"/>
                      </a:moveTo>
                      <a:lnTo>
                        <a:pt x="0" y="159"/>
                      </a:lnTo>
                      <a:lnTo>
                        <a:pt x="454" y="159"/>
                      </a:lnTo>
                    </a:path>
                  </a:pathLst>
                </a:custGeom>
                <a:noFill/>
                <a:ln w="270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"/>
                <p:cNvSpPr/>
                <p:nvPr/>
              </p:nvSpPr>
              <p:spPr>
                <a:xfrm>
                  <a:off x="2384280" y="3249360"/>
                  <a:ext cx="719280" cy="324000"/>
                </a:xfrm>
                <a:custGeom>
                  <a:avLst/>
                  <a:gdLst/>
                  <a:ahLst/>
                  <a:rect l="l" t="t" r="r" b="b"/>
                  <a:pathLst>
                    <a:path w="453" h="204">
                      <a:moveTo>
                        <a:pt x="0" y="204"/>
                      </a:moveTo>
                      <a:lnTo>
                        <a:pt x="0" y="0"/>
                      </a:lnTo>
                      <a:lnTo>
                        <a:pt x="453" y="0"/>
                      </a:lnTo>
                    </a:path>
                  </a:pathLst>
                </a:custGeom>
                <a:noFill/>
                <a:ln w="270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"/>
                <p:cNvSpPr/>
                <p:nvPr/>
              </p:nvSpPr>
              <p:spPr>
                <a:xfrm>
                  <a:off x="4560480" y="3808440"/>
                  <a:ext cx="7581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fr-FR" sz="1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i="1" lang="fr-FR" sz="1200" spc="-1" strike="noStrike">
                      <a:solidFill>
                        <a:srgbClr val="000000"/>
                      </a:solidFill>
                      <a:latin typeface="Arial"/>
                    </a:rPr>
                    <a:t>P.pacifica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"/>
                <p:cNvSpPr/>
                <p:nvPr/>
              </p:nvSpPr>
              <p:spPr>
                <a:xfrm>
                  <a:off x="2384280" y="3600360"/>
                  <a:ext cx="2159280" cy="323640"/>
                </a:xfrm>
                <a:custGeom>
                  <a:avLst/>
                  <a:gdLst/>
                  <a:ahLst/>
                  <a:rect l="l" t="t" r="r" b="b"/>
                  <a:pathLst>
                    <a:path w="1360" h="204">
                      <a:moveTo>
                        <a:pt x="0" y="0"/>
                      </a:moveTo>
                      <a:lnTo>
                        <a:pt x="0" y="204"/>
                      </a:lnTo>
                      <a:lnTo>
                        <a:pt x="1360" y="204"/>
                      </a:lnTo>
                    </a:path>
                  </a:pathLst>
                </a:custGeom>
                <a:noFill/>
                <a:ln w="270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"/>
                <p:cNvSpPr/>
                <p:nvPr/>
              </p:nvSpPr>
              <p:spPr>
                <a:xfrm>
                  <a:off x="1663560" y="3590640"/>
                  <a:ext cx="720720" cy="289080"/>
                </a:xfrm>
                <a:custGeom>
                  <a:avLst/>
                  <a:gdLst/>
                  <a:ahLst/>
                  <a:rect l="l" t="t" r="r" b="b"/>
                  <a:pathLst>
                    <a:path w="454" h="182">
                      <a:moveTo>
                        <a:pt x="0" y="182"/>
                      </a:moveTo>
                      <a:lnTo>
                        <a:pt x="0" y="0"/>
                      </a:lnTo>
                      <a:lnTo>
                        <a:pt x="454" y="0"/>
                      </a:lnTo>
                    </a:path>
                  </a:pathLst>
                </a:custGeom>
                <a:noFill/>
                <a:ln w="270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"/>
                <p:cNvSpPr/>
                <p:nvPr/>
              </p:nvSpPr>
              <p:spPr>
                <a:xfrm>
                  <a:off x="4561920" y="4078080"/>
                  <a:ext cx="7812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fr-FR" sz="1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i="1" lang="fr-FR" sz="1200" spc="-1" strike="noStrike">
                      <a:solidFill>
                        <a:srgbClr val="000000"/>
                      </a:solidFill>
                      <a:latin typeface="Arial"/>
                    </a:rPr>
                    <a:t>Beggiatoa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"/>
                <p:cNvSpPr/>
                <p:nvPr/>
              </p:nvSpPr>
              <p:spPr>
                <a:xfrm>
                  <a:off x="1663560" y="3906720"/>
                  <a:ext cx="2880000" cy="287280"/>
                </a:xfrm>
                <a:custGeom>
                  <a:avLst/>
                  <a:gdLst/>
                  <a:ahLst/>
                  <a:rect l="l" t="t" r="r" b="b"/>
                  <a:pathLst>
                    <a:path w="1814" h="181">
                      <a:moveTo>
                        <a:pt x="0" y="0"/>
                      </a:moveTo>
                      <a:lnTo>
                        <a:pt x="0" y="181"/>
                      </a:lnTo>
                      <a:lnTo>
                        <a:pt x="1814" y="181"/>
                      </a:lnTo>
                    </a:path>
                  </a:pathLst>
                </a:custGeom>
                <a:noFill/>
                <a:ln w="270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"/>
                <p:cNvSpPr/>
                <p:nvPr/>
              </p:nvSpPr>
              <p:spPr>
                <a:xfrm>
                  <a:off x="944640" y="3897000"/>
                  <a:ext cx="718920" cy="270000"/>
                </a:xfrm>
                <a:custGeom>
                  <a:avLst/>
                  <a:gdLst/>
                  <a:ahLst/>
                  <a:rect l="l" t="t" r="r" b="b"/>
                  <a:pathLst>
                    <a:path w="453" h="170">
                      <a:moveTo>
                        <a:pt x="0" y="170"/>
                      </a:moveTo>
                      <a:lnTo>
                        <a:pt x="0" y="0"/>
                      </a:lnTo>
                      <a:lnTo>
                        <a:pt x="453" y="0"/>
                      </a:lnTo>
                    </a:path>
                  </a:pathLst>
                </a:custGeom>
                <a:noFill/>
                <a:ln w="270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"/>
                <p:cNvSpPr/>
                <p:nvPr/>
              </p:nvSpPr>
              <p:spPr>
                <a:xfrm>
                  <a:off x="4562280" y="4348080"/>
                  <a:ext cx="80712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fr-FR" sz="1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i="1" lang="fr-FR" sz="1200" spc="-1" strike="noStrike">
                      <a:solidFill>
                        <a:srgbClr val="000000"/>
                      </a:solidFill>
                      <a:latin typeface="Arial"/>
                    </a:rPr>
                    <a:t>C.watsonii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"/>
                <p:cNvSpPr/>
                <p:nvPr/>
              </p:nvSpPr>
              <p:spPr>
                <a:xfrm>
                  <a:off x="944640" y="4194000"/>
                  <a:ext cx="3598920" cy="271440"/>
                </a:xfrm>
                <a:custGeom>
                  <a:avLst/>
                  <a:gdLst/>
                  <a:ahLst/>
                  <a:rect l="l" t="t" r="r" b="b"/>
                  <a:pathLst>
                    <a:path w="2267" h="171">
                      <a:moveTo>
                        <a:pt x="0" y="0"/>
                      </a:moveTo>
                      <a:lnTo>
                        <a:pt x="0" y="171"/>
                      </a:lnTo>
                      <a:lnTo>
                        <a:pt x="2267" y="171"/>
                      </a:lnTo>
                    </a:path>
                  </a:pathLst>
                </a:custGeom>
                <a:noFill/>
                <a:ln w="2700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64" name=""/>
            <p:cNvGrpSpPr/>
            <p:nvPr/>
          </p:nvGrpSpPr>
          <p:grpSpPr>
            <a:xfrm>
              <a:off x="1800" y="104760"/>
              <a:ext cx="5407920" cy="2446560"/>
              <a:chOff x="1800" y="104760"/>
              <a:chExt cx="5407920" cy="2446560"/>
            </a:xfrm>
          </p:grpSpPr>
          <p:sp>
            <p:nvSpPr>
              <p:cNvPr id="65" name=""/>
              <p:cNvSpPr/>
              <p:nvPr/>
            </p:nvSpPr>
            <p:spPr>
              <a:xfrm>
                <a:off x="1800" y="104760"/>
                <a:ext cx="345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2962800" y="207720"/>
                <a:ext cx="6469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A.viridi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1668600" y="325440"/>
                <a:ext cx="1277640" cy="125280"/>
              </a:xfrm>
              <a:custGeom>
                <a:avLst/>
                <a:gdLst/>
                <a:ahLst/>
                <a:rect l="l" t="t" r="r" b="b"/>
                <a:pathLst>
                  <a:path w="805" h="79">
                    <a:moveTo>
                      <a:pt x="0" y="79"/>
                    </a:moveTo>
                    <a:lnTo>
                      <a:pt x="0" y="0"/>
                    </a:lnTo>
                    <a:lnTo>
                      <a:pt x="805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2845440" y="479520"/>
                <a:ext cx="875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A.millepor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1668600" y="477720"/>
                <a:ext cx="1160280" cy="117360"/>
              </a:xfrm>
              <a:custGeom>
                <a:avLst/>
                <a:gdLst/>
                <a:ahLst/>
                <a:rect l="l" t="t" r="r" b="b"/>
                <a:pathLst>
                  <a:path w="731" h="74">
                    <a:moveTo>
                      <a:pt x="0" y="0"/>
                    </a:moveTo>
                    <a:lnTo>
                      <a:pt x="0" y="74"/>
                    </a:lnTo>
                    <a:lnTo>
                      <a:pt x="731" y="74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1271520" y="460440"/>
                <a:ext cx="397080" cy="260280"/>
              </a:xfrm>
              <a:custGeom>
                <a:avLst/>
                <a:gdLst/>
                <a:ahLst/>
                <a:rect l="l" t="t" r="r" b="b"/>
                <a:pathLst>
                  <a:path w="250" h="164">
                    <a:moveTo>
                      <a:pt x="0" y="164"/>
                    </a:moveTo>
                    <a:lnTo>
                      <a:pt x="0" y="0"/>
                    </a:lnTo>
                    <a:lnTo>
                      <a:pt x="25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3142080" y="749160"/>
                <a:ext cx="833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C.briggsa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2387520" y="865080"/>
                <a:ext cx="738360" cy="125280"/>
              </a:xfrm>
              <a:custGeom>
                <a:avLst/>
                <a:gdLst/>
                <a:ahLst/>
                <a:rect l="l" t="t" r="r" b="b"/>
                <a:pathLst>
                  <a:path w="465" h="79">
                    <a:moveTo>
                      <a:pt x="0" y="79"/>
                    </a:moveTo>
                    <a:lnTo>
                      <a:pt x="0" y="0"/>
                    </a:lnTo>
                    <a:lnTo>
                      <a:pt x="465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3906360" y="1019160"/>
                <a:ext cx="7660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C.elegan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2387520" y="1017360"/>
                <a:ext cx="1513080" cy="117720"/>
              </a:xfrm>
              <a:custGeom>
                <a:avLst/>
                <a:gdLst/>
                <a:ahLst/>
                <a:rect l="l" t="t" r="r" b="b"/>
                <a:pathLst>
                  <a:path w="953" h="74">
                    <a:moveTo>
                      <a:pt x="0" y="0"/>
                    </a:moveTo>
                    <a:lnTo>
                      <a:pt x="0" y="74"/>
                    </a:lnTo>
                    <a:lnTo>
                      <a:pt x="953" y="74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1271520" y="747720"/>
                <a:ext cx="1116000" cy="252360"/>
              </a:xfrm>
              <a:custGeom>
                <a:avLst/>
                <a:gdLst/>
                <a:ahLst/>
                <a:rect l="l" t="t" r="r" b="b"/>
                <a:pathLst>
                  <a:path w="703" h="159">
                    <a:moveTo>
                      <a:pt x="0" y="0"/>
                    </a:moveTo>
                    <a:lnTo>
                      <a:pt x="0" y="159"/>
                    </a:lnTo>
                    <a:lnTo>
                      <a:pt x="703" y="159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1011240" y="730080"/>
                <a:ext cx="260280" cy="324000"/>
              </a:xfrm>
              <a:custGeom>
                <a:avLst/>
                <a:gdLst/>
                <a:ahLst/>
                <a:rect l="l" t="t" r="r" b="b"/>
                <a:pathLst>
                  <a:path w="164" h="204">
                    <a:moveTo>
                      <a:pt x="0" y="204"/>
                    </a:moveTo>
                    <a:lnTo>
                      <a:pt x="0" y="0"/>
                    </a:lnTo>
                    <a:lnTo>
                      <a:pt x="164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3538080" y="1288800"/>
                <a:ext cx="758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P.pacific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1011240" y="1081080"/>
                <a:ext cx="2519280" cy="323640"/>
              </a:xfrm>
              <a:custGeom>
                <a:avLst/>
                <a:gdLst/>
                <a:ahLst/>
                <a:rect l="l" t="t" r="r" b="b"/>
                <a:pathLst>
                  <a:path w="1587" h="204">
                    <a:moveTo>
                      <a:pt x="0" y="0"/>
                    </a:moveTo>
                    <a:lnTo>
                      <a:pt x="0" y="204"/>
                    </a:lnTo>
                    <a:lnTo>
                      <a:pt x="1587" y="204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4628520" y="1558800"/>
                <a:ext cx="7812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Beggiato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3152880" y="1674720"/>
                <a:ext cx="1458720" cy="125280"/>
              </a:xfrm>
              <a:custGeom>
                <a:avLst/>
                <a:gdLst/>
                <a:ahLst/>
                <a:rect l="l" t="t" r="r" b="b"/>
                <a:pathLst>
                  <a:path w="919" h="79">
                    <a:moveTo>
                      <a:pt x="0" y="79"/>
                    </a:moveTo>
                    <a:lnTo>
                      <a:pt x="0" y="0"/>
                    </a:lnTo>
                    <a:lnTo>
                      <a:pt x="919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4422600" y="1828800"/>
                <a:ext cx="807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C.watsonii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3152880" y="1827000"/>
                <a:ext cx="1260360" cy="117720"/>
              </a:xfrm>
              <a:custGeom>
                <a:avLst/>
                <a:gdLst/>
                <a:ahLst/>
                <a:rect l="l" t="t" r="r" b="b"/>
                <a:pathLst>
                  <a:path w="794" h="74">
                    <a:moveTo>
                      <a:pt x="0" y="0"/>
                    </a:moveTo>
                    <a:lnTo>
                      <a:pt x="0" y="74"/>
                    </a:lnTo>
                    <a:lnTo>
                      <a:pt x="794" y="74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1011240" y="1287360"/>
                <a:ext cx="2141640" cy="522360"/>
              </a:xfrm>
              <a:custGeom>
                <a:avLst/>
                <a:gdLst/>
                <a:ahLst/>
                <a:rect l="l" t="t" r="r" b="b"/>
                <a:pathLst>
                  <a:path w="1349" h="329">
                    <a:moveTo>
                      <a:pt x="0" y="0"/>
                    </a:moveTo>
                    <a:lnTo>
                      <a:pt x="0" y="329"/>
                    </a:lnTo>
                    <a:lnTo>
                      <a:pt x="1349" y="329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1011240" y="730080"/>
                <a:ext cx="1440" cy="5302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1460520" y="2332080"/>
                <a:ext cx="6476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1460520" y="2295360"/>
                <a:ext cx="1440" cy="7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2108160" y="2295360"/>
                <a:ext cx="1800" cy="7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1711440" y="2368440"/>
                <a:ext cx="2142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0.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9" name=""/>
            <p:cNvGrpSpPr/>
            <p:nvPr/>
          </p:nvGrpSpPr>
          <p:grpSpPr>
            <a:xfrm>
              <a:off x="1800" y="5027400"/>
              <a:ext cx="5510520" cy="2532600"/>
              <a:chOff x="1800" y="5027400"/>
              <a:chExt cx="5510520" cy="2532600"/>
            </a:xfrm>
          </p:grpSpPr>
          <p:sp>
            <p:nvSpPr>
              <p:cNvPr id="90" name=""/>
              <p:cNvSpPr/>
              <p:nvPr/>
            </p:nvSpPr>
            <p:spPr>
              <a:xfrm>
                <a:off x="1800" y="5027400"/>
                <a:ext cx="345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91" name="" descr=""/>
              <p:cNvPicPr/>
              <p:nvPr/>
            </p:nvPicPr>
            <p:blipFill>
              <a:blip r:embed="rId1">
                <a:biLevel thresh="50000"/>
                <a:lum contrast="100000"/>
              </a:blip>
              <a:srcRect l="1562" t="11252" r="30156" b="15749"/>
              <a:stretch/>
            </p:blipFill>
            <p:spPr>
              <a:xfrm>
                <a:off x="1028520" y="5040360"/>
                <a:ext cx="3743280" cy="2501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2" name=""/>
              <p:cNvSpPr/>
              <p:nvPr/>
            </p:nvSpPr>
            <p:spPr>
              <a:xfrm>
                <a:off x="3859560" y="5035680"/>
                <a:ext cx="6469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A.viridi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3961080" y="5430960"/>
                <a:ext cx="8755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A.millepor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4257720" y="5815080"/>
                <a:ext cx="833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C.briggsa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4746240" y="6208560"/>
                <a:ext cx="7660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C.elegan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3615840" y="6602400"/>
                <a:ext cx="758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P.pacific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1734120" y="7377120"/>
                <a:ext cx="7812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Beggiato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1728360" y="6989760"/>
                <a:ext cx="807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i="1" lang="fr-FR" sz="1200" spc="-1" strike="noStrike">
                    <a:solidFill>
                      <a:srgbClr val="000000"/>
                    </a:solidFill>
                    <a:latin typeface="Arial"/>
                  </a:rPr>
                  <a:t>C.watsonii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21T13:38:28Z</dcterms:created>
  <dc:creator>Sil</dc:creator>
  <dc:description/>
  <dc:language>en-US</dc:language>
  <cp:lastModifiedBy>Sil</cp:lastModifiedBy>
  <dcterms:modified xsi:type="dcterms:W3CDTF">2009-07-21T13:40:50Z</dcterms:modified>
  <cp:revision>1</cp:revision>
  <dc:subject/>
  <dc:title>Diapositive 1</dc:title>
</cp:coreProperties>
</file>